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8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0" d="100"/>
          <a:sy n="60" d="100"/>
        </p:scale>
        <p:origin x="908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ceday\Desktop\16RT&#25991;&#31456;\HR\&#25968;&#25454;\HJxZ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ceday\Desktop\16RT&#25991;&#31456;\HR\&#25968;&#25454;\HJxZK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niceday\Desktop\16RT&#25991;&#31456;\HR\&#25968;&#25454;\HBxFC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niceday\Desktop\16RT&#25991;&#31456;\HR\&#25968;&#25454;\HBxF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3396242971292701E-2"/>
          <c:y val="6.26287574902194E-2"/>
          <c:w val="0.95604802063829497"/>
          <c:h val="0.80985551923933996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Flavanone rutinoside</c:f>
              <c:strCache>
                <c:ptCount val="1"/>
                <c:pt idx="0">
                  <c:v>Flavanone rutinosid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比例!$A$5:$A$72</c:f>
              <c:strCache>
                <c:ptCount val="68"/>
                <c:pt idx="0">
                  <c:v>HJ</c:v>
                </c:pt>
                <c:pt idx="1">
                  <c:v>ZK</c:v>
                </c:pt>
                <c:pt idx="2">
                  <c:v>ZJ72</c:v>
                </c:pt>
                <c:pt idx="3">
                  <c:v>ZJ80</c:v>
                </c:pt>
                <c:pt idx="4">
                  <c:v>ZJ58</c:v>
                </c:pt>
                <c:pt idx="5">
                  <c:v>ZJ54</c:v>
                </c:pt>
                <c:pt idx="6">
                  <c:v>ZJ56</c:v>
                </c:pt>
                <c:pt idx="7">
                  <c:v>ZJ7</c:v>
                </c:pt>
                <c:pt idx="8">
                  <c:v>ZJ97</c:v>
                </c:pt>
                <c:pt idx="9">
                  <c:v>ZJ10</c:v>
                </c:pt>
                <c:pt idx="10">
                  <c:v>ZJ41</c:v>
                </c:pt>
                <c:pt idx="11">
                  <c:v>ZJ71</c:v>
                </c:pt>
                <c:pt idx="12">
                  <c:v>ZJ1</c:v>
                </c:pt>
                <c:pt idx="13">
                  <c:v>ZJ50</c:v>
                </c:pt>
                <c:pt idx="14">
                  <c:v>ZJ26</c:v>
                </c:pt>
                <c:pt idx="15">
                  <c:v>ZJ16</c:v>
                </c:pt>
                <c:pt idx="16">
                  <c:v>ZJ20</c:v>
                </c:pt>
                <c:pt idx="17">
                  <c:v>ZJ82</c:v>
                </c:pt>
                <c:pt idx="18">
                  <c:v>ZJ84</c:v>
                </c:pt>
                <c:pt idx="19">
                  <c:v>ZJ61</c:v>
                </c:pt>
                <c:pt idx="20">
                  <c:v>ZJ63</c:v>
                </c:pt>
                <c:pt idx="21">
                  <c:v>ZJ33</c:v>
                </c:pt>
                <c:pt idx="22">
                  <c:v>ZJ49</c:v>
                </c:pt>
                <c:pt idx="23">
                  <c:v>ZJ29</c:v>
                </c:pt>
                <c:pt idx="24">
                  <c:v>ZJ25</c:v>
                </c:pt>
                <c:pt idx="25">
                  <c:v>ZJ22</c:v>
                </c:pt>
                <c:pt idx="26">
                  <c:v>ZJ37</c:v>
                </c:pt>
                <c:pt idx="27">
                  <c:v>ZJ77</c:v>
                </c:pt>
                <c:pt idx="28">
                  <c:v>ZJ40</c:v>
                </c:pt>
                <c:pt idx="29">
                  <c:v>ZJ85</c:v>
                </c:pt>
                <c:pt idx="30">
                  <c:v>ZJ21</c:v>
                </c:pt>
                <c:pt idx="31">
                  <c:v>ZJ60</c:v>
                </c:pt>
                <c:pt idx="32">
                  <c:v>ZJ31</c:v>
                </c:pt>
                <c:pt idx="33">
                  <c:v>ZJ96</c:v>
                </c:pt>
                <c:pt idx="34">
                  <c:v>ZJ106</c:v>
                </c:pt>
                <c:pt idx="35">
                  <c:v>ZJ87</c:v>
                </c:pt>
                <c:pt idx="36">
                  <c:v>ZJ19</c:v>
                </c:pt>
                <c:pt idx="37">
                  <c:v>ZJ27</c:v>
                </c:pt>
                <c:pt idx="38">
                  <c:v>ZJ62</c:v>
                </c:pt>
                <c:pt idx="39">
                  <c:v>ZJ39</c:v>
                </c:pt>
                <c:pt idx="40">
                  <c:v>ZJ89</c:v>
                </c:pt>
                <c:pt idx="41">
                  <c:v>ZJ14</c:v>
                </c:pt>
                <c:pt idx="42">
                  <c:v>ZJ79</c:v>
                </c:pt>
                <c:pt idx="43">
                  <c:v>ZJ102</c:v>
                </c:pt>
                <c:pt idx="44">
                  <c:v>ZJ11</c:v>
                </c:pt>
                <c:pt idx="45">
                  <c:v>ZJ9</c:v>
                </c:pt>
                <c:pt idx="46">
                  <c:v>ZJ90</c:v>
                </c:pt>
                <c:pt idx="47">
                  <c:v>ZJ81</c:v>
                </c:pt>
                <c:pt idx="48">
                  <c:v>ZJ104</c:v>
                </c:pt>
                <c:pt idx="49">
                  <c:v>ZJ47</c:v>
                </c:pt>
                <c:pt idx="50">
                  <c:v>ZJ5</c:v>
                </c:pt>
                <c:pt idx="51">
                  <c:v>ZJ34</c:v>
                </c:pt>
                <c:pt idx="52">
                  <c:v>ZJ55</c:v>
                </c:pt>
                <c:pt idx="53">
                  <c:v>ZJ95</c:v>
                </c:pt>
                <c:pt idx="54">
                  <c:v>ZJ109</c:v>
                </c:pt>
                <c:pt idx="55">
                  <c:v>ZJ30</c:v>
                </c:pt>
                <c:pt idx="56">
                  <c:v>ZJ66</c:v>
                </c:pt>
                <c:pt idx="57">
                  <c:v>ZJ99</c:v>
                </c:pt>
                <c:pt idx="58">
                  <c:v>ZJ59</c:v>
                </c:pt>
                <c:pt idx="59">
                  <c:v>ZJ98</c:v>
                </c:pt>
                <c:pt idx="60">
                  <c:v>ZJ35</c:v>
                </c:pt>
                <c:pt idx="61">
                  <c:v>ZJ57</c:v>
                </c:pt>
                <c:pt idx="62">
                  <c:v>ZJ36</c:v>
                </c:pt>
                <c:pt idx="63">
                  <c:v>ZJ70</c:v>
                </c:pt>
                <c:pt idx="64">
                  <c:v>ZJ108</c:v>
                </c:pt>
                <c:pt idx="65">
                  <c:v>ZJ2</c:v>
                </c:pt>
                <c:pt idx="66">
                  <c:v>ZJ67</c:v>
                </c:pt>
                <c:pt idx="67">
                  <c:v>ZJ73</c:v>
                </c:pt>
              </c:strCache>
            </c:strRef>
          </c:cat>
          <c:val>
            <c:numRef>
              <c:f>比例!$B$5:$B$72</c:f>
              <c:numCache>
                <c:formatCode>0.00;[Red]0.00</c:formatCode>
                <c:ptCount val="68"/>
                <c:pt idx="0">
                  <c:v>10.0647863527679</c:v>
                </c:pt>
                <c:pt idx="1">
                  <c:v>3.3989128453666</c:v>
                </c:pt>
                <c:pt idx="2">
                  <c:v>21.6375751431592</c:v>
                </c:pt>
                <c:pt idx="3">
                  <c:v>19.376466592793701</c:v>
                </c:pt>
                <c:pt idx="4">
                  <c:v>19.375948345003099</c:v>
                </c:pt>
                <c:pt idx="5">
                  <c:v>18.864819850517101</c:v>
                </c:pt>
                <c:pt idx="6">
                  <c:v>16.306089814448899</c:v>
                </c:pt>
                <c:pt idx="7">
                  <c:v>15.8314091684743</c:v>
                </c:pt>
                <c:pt idx="8">
                  <c:v>15.275341468762599</c:v>
                </c:pt>
                <c:pt idx="9">
                  <c:v>15.0147662739474</c:v>
                </c:pt>
                <c:pt idx="10">
                  <c:v>14.117532281898299</c:v>
                </c:pt>
                <c:pt idx="11">
                  <c:v>14.040037253478101</c:v>
                </c:pt>
                <c:pt idx="12">
                  <c:v>13.955556874229099</c:v>
                </c:pt>
                <c:pt idx="13">
                  <c:v>13.358559132248599</c:v>
                </c:pt>
                <c:pt idx="14">
                  <c:v>13.1095400336695</c:v>
                </c:pt>
                <c:pt idx="15">
                  <c:v>12.643951087521501</c:v>
                </c:pt>
                <c:pt idx="16">
                  <c:v>12.642121949117101</c:v>
                </c:pt>
                <c:pt idx="17">
                  <c:v>12.5301223101979</c:v>
                </c:pt>
                <c:pt idx="18">
                  <c:v>12.3629923439586</c:v>
                </c:pt>
                <c:pt idx="19">
                  <c:v>11.613086149986399</c:v>
                </c:pt>
                <c:pt idx="20">
                  <c:v>11.156128613983</c:v>
                </c:pt>
                <c:pt idx="21">
                  <c:v>11.1193663392754</c:v>
                </c:pt>
                <c:pt idx="22">
                  <c:v>10.775088643048599</c:v>
                </c:pt>
                <c:pt idx="23">
                  <c:v>10.6121452308484</c:v>
                </c:pt>
                <c:pt idx="24">
                  <c:v>10.4975192417696</c:v>
                </c:pt>
                <c:pt idx="25">
                  <c:v>9.5181599961844991</c:v>
                </c:pt>
                <c:pt idx="26">
                  <c:v>8.8097894167817294</c:v>
                </c:pt>
                <c:pt idx="27">
                  <c:v>8.5333789252627898</c:v>
                </c:pt>
                <c:pt idx="28">
                  <c:v>6.6767143672021998</c:v>
                </c:pt>
                <c:pt idx="29">
                  <c:v>6.3491862628865201</c:v>
                </c:pt>
                <c:pt idx="30">
                  <c:v>5.8506293226402404</c:v>
                </c:pt>
                <c:pt idx="31">
                  <c:v>5.6038218850408104</c:v>
                </c:pt>
                <c:pt idx="32">
                  <c:v>5.2897705239016597</c:v>
                </c:pt>
                <c:pt idx="33">
                  <c:v>4.6276123830421501</c:v>
                </c:pt>
                <c:pt idx="34">
                  <c:v>4.1295800131482903</c:v>
                </c:pt>
                <c:pt idx="35">
                  <c:v>4.0428335367242196</c:v>
                </c:pt>
                <c:pt idx="36">
                  <c:v>3.9959339013053201</c:v>
                </c:pt>
                <c:pt idx="37">
                  <c:v>3.9779120036478401</c:v>
                </c:pt>
                <c:pt idx="38">
                  <c:v>3.9550165734342002</c:v>
                </c:pt>
                <c:pt idx="39">
                  <c:v>3.9503551343741798</c:v>
                </c:pt>
                <c:pt idx="40">
                  <c:v>3.8994816353856101</c:v>
                </c:pt>
                <c:pt idx="41">
                  <c:v>3.8470656757490498</c:v>
                </c:pt>
                <c:pt idx="42">
                  <c:v>3.8332551239335602</c:v>
                </c:pt>
                <c:pt idx="43">
                  <c:v>3.7154785689635199</c:v>
                </c:pt>
                <c:pt idx="44">
                  <c:v>3.6901735863075902</c:v>
                </c:pt>
                <c:pt idx="45">
                  <c:v>3.4841340367540701</c:v>
                </c:pt>
                <c:pt idx="46">
                  <c:v>3.4808075578310902</c:v>
                </c:pt>
                <c:pt idx="47">
                  <c:v>3.3007745609125898</c:v>
                </c:pt>
                <c:pt idx="48">
                  <c:v>3.27223325134212</c:v>
                </c:pt>
                <c:pt idx="49">
                  <c:v>3.1517089177087301</c:v>
                </c:pt>
                <c:pt idx="50">
                  <c:v>2.9472373644495802</c:v>
                </c:pt>
                <c:pt idx="51">
                  <c:v>2.8688474326986499</c:v>
                </c:pt>
                <c:pt idx="52">
                  <c:v>2.8671481629246101</c:v>
                </c:pt>
                <c:pt idx="53">
                  <c:v>2.7375712197859299</c:v>
                </c:pt>
                <c:pt idx="54">
                  <c:v>2.6411225307154198</c:v>
                </c:pt>
                <c:pt idx="55">
                  <c:v>2.60608461042793</c:v>
                </c:pt>
                <c:pt idx="56">
                  <c:v>2.59002129923697</c:v>
                </c:pt>
                <c:pt idx="57">
                  <c:v>2.5417188424675801</c:v>
                </c:pt>
                <c:pt idx="58">
                  <c:v>2.5155458604361498</c:v>
                </c:pt>
                <c:pt idx="59">
                  <c:v>2.4947055398194</c:v>
                </c:pt>
                <c:pt idx="60">
                  <c:v>2.3636918155726399</c:v>
                </c:pt>
                <c:pt idx="61">
                  <c:v>2.3608552995096499</c:v>
                </c:pt>
                <c:pt idx="62">
                  <c:v>2.3580542096671402</c:v>
                </c:pt>
                <c:pt idx="63">
                  <c:v>2.22591414871814</c:v>
                </c:pt>
                <c:pt idx="64">
                  <c:v>2.1868119203446801</c:v>
                </c:pt>
                <c:pt idx="65">
                  <c:v>2.1669679932618302</c:v>
                </c:pt>
                <c:pt idx="66">
                  <c:v>2.0911053391640602</c:v>
                </c:pt>
                <c:pt idx="67">
                  <c:v>1.8616574687215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C2A-4A5F-A4E5-01564DB0C2B8}"/>
            </c:ext>
          </c:extLst>
        </c:ser>
        <c:ser>
          <c:idx val="1"/>
          <c:order val="1"/>
          <c:tx>
            <c:strRef>
              <c:f>Flavanone neohesperidoside</c:f>
              <c:strCache>
                <c:ptCount val="1"/>
                <c:pt idx="0">
                  <c:v>Flavanone neohesperidosid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比例!$A$5:$A$72</c:f>
              <c:strCache>
                <c:ptCount val="68"/>
                <c:pt idx="0">
                  <c:v>HJ</c:v>
                </c:pt>
                <c:pt idx="1">
                  <c:v>ZK</c:v>
                </c:pt>
                <c:pt idx="2">
                  <c:v>ZJ72</c:v>
                </c:pt>
                <c:pt idx="3">
                  <c:v>ZJ80</c:v>
                </c:pt>
                <c:pt idx="4">
                  <c:v>ZJ58</c:v>
                </c:pt>
                <c:pt idx="5">
                  <c:v>ZJ54</c:v>
                </c:pt>
                <c:pt idx="6">
                  <c:v>ZJ56</c:v>
                </c:pt>
                <c:pt idx="7">
                  <c:v>ZJ7</c:v>
                </c:pt>
                <c:pt idx="8">
                  <c:v>ZJ97</c:v>
                </c:pt>
                <c:pt idx="9">
                  <c:v>ZJ10</c:v>
                </c:pt>
                <c:pt idx="10">
                  <c:v>ZJ41</c:v>
                </c:pt>
                <c:pt idx="11">
                  <c:v>ZJ71</c:v>
                </c:pt>
                <c:pt idx="12">
                  <c:v>ZJ1</c:v>
                </c:pt>
                <c:pt idx="13">
                  <c:v>ZJ50</c:v>
                </c:pt>
                <c:pt idx="14">
                  <c:v>ZJ26</c:v>
                </c:pt>
                <c:pt idx="15">
                  <c:v>ZJ16</c:v>
                </c:pt>
                <c:pt idx="16">
                  <c:v>ZJ20</c:v>
                </c:pt>
                <c:pt idx="17">
                  <c:v>ZJ82</c:v>
                </c:pt>
                <c:pt idx="18">
                  <c:v>ZJ84</c:v>
                </c:pt>
                <c:pt idx="19">
                  <c:v>ZJ61</c:v>
                </c:pt>
                <c:pt idx="20">
                  <c:v>ZJ63</c:v>
                </c:pt>
                <c:pt idx="21">
                  <c:v>ZJ33</c:v>
                </c:pt>
                <c:pt idx="22">
                  <c:v>ZJ49</c:v>
                </c:pt>
                <c:pt idx="23">
                  <c:v>ZJ29</c:v>
                </c:pt>
                <c:pt idx="24">
                  <c:v>ZJ25</c:v>
                </c:pt>
                <c:pt idx="25">
                  <c:v>ZJ22</c:v>
                </c:pt>
                <c:pt idx="26">
                  <c:v>ZJ37</c:v>
                </c:pt>
                <c:pt idx="27">
                  <c:v>ZJ77</c:v>
                </c:pt>
                <c:pt idx="28">
                  <c:v>ZJ40</c:v>
                </c:pt>
                <c:pt idx="29">
                  <c:v>ZJ85</c:v>
                </c:pt>
                <c:pt idx="30">
                  <c:v>ZJ21</c:v>
                </c:pt>
                <c:pt idx="31">
                  <c:v>ZJ60</c:v>
                </c:pt>
                <c:pt idx="32">
                  <c:v>ZJ31</c:v>
                </c:pt>
                <c:pt idx="33">
                  <c:v>ZJ96</c:v>
                </c:pt>
                <c:pt idx="34">
                  <c:v>ZJ106</c:v>
                </c:pt>
                <c:pt idx="35">
                  <c:v>ZJ87</c:v>
                </c:pt>
                <c:pt idx="36">
                  <c:v>ZJ19</c:v>
                </c:pt>
                <c:pt idx="37">
                  <c:v>ZJ27</c:v>
                </c:pt>
                <c:pt idx="38">
                  <c:v>ZJ62</c:v>
                </c:pt>
                <c:pt idx="39">
                  <c:v>ZJ39</c:v>
                </c:pt>
                <c:pt idx="40">
                  <c:v>ZJ89</c:v>
                </c:pt>
                <c:pt idx="41">
                  <c:v>ZJ14</c:v>
                </c:pt>
                <c:pt idx="42">
                  <c:v>ZJ79</c:v>
                </c:pt>
                <c:pt idx="43">
                  <c:v>ZJ102</c:v>
                </c:pt>
                <c:pt idx="44">
                  <c:v>ZJ11</c:v>
                </c:pt>
                <c:pt idx="45">
                  <c:v>ZJ9</c:v>
                </c:pt>
                <c:pt idx="46">
                  <c:v>ZJ90</c:v>
                </c:pt>
                <c:pt idx="47">
                  <c:v>ZJ81</c:v>
                </c:pt>
                <c:pt idx="48">
                  <c:v>ZJ104</c:v>
                </c:pt>
                <c:pt idx="49">
                  <c:v>ZJ47</c:v>
                </c:pt>
                <c:pt idx="50">
                  <c:v>ZJ5</c:v>
                </c:pt>
                <c:pt idx="51">
                  <c:v>ZJ34</c:v>
                </c:pt>
                <c:pt idx="52">
                  <c:v>ZJ55</c:v>
                </c:pt>
                <c:pt idx="53">
                  <c:v>ZJ95</c:v>
                </c:pt>
                <c:pt idx="54">
                  <c:v>ZJ109</c:v>
                </c:pt>
                <c:pt idx="55">
                  <c:v>ZJ30</c:v>
                </c:pt>
                <c:pt idx="56">
                  <c:v>ZJ66</c:v>
                </c:pt>
                <c:pt idx="57">
                  <c:v>ZJ99</c:v>
                </c:pt>
                <c:pt idx="58">
                  <c:v>ZJ59</c:v>
                </c:pt>
                <c:pt idx="59">
                  <c:v>ZJ98</c:v>
                </c:pt>
                <c:pt idx="60">
                  <c:v>ZJ35</c:v>
                </c:pt>
                <c:pt idx="61">
                  <c:v>ZJ57</c:v>
                </c:pt>
                <c:pt idx="62">
                  <c:v>ZJ36</c:v>
                </c:pt>
                <c:pt idx="63">
                  <c:v>ZJ70</c:v>
                </c:pt>
                <c:pt idx="64">
                  <c:v>ZJ108</c:v>
                </c:pt>
                <c:pt idx="65">
                  <c:v>ZJ2</c:v>
                </c:pt>
                <c:pt idx="66">
                  <c:v>ZJ67</c:v>
                </c:pt>
                <c:pt idx="67">
                  <c:v>ZJ73</c:v>
                </c:pt>
              </c:strCache>
            </c:strRef>
          </c:cat>
          <c:val>
            <c:numRef>
              <c:f>比例!$C$5:$C$72</c:f>
              <c:numCache>
                <c:formatCode>0.00;[Red]0.00</c:formatCode>
                <c:ptCount val="68"/>
                <c:pt idx="0">
                  <c:v>0</c:v>
                </c:pt>
                <c:pt idx="1">
                  <c:v>11.65332787170840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29486465251607802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.48973320870928</c:v>
                </c:pt>
                <c:pt idx="28">
                  <c:v>0</c:v>
                </c:pt>
                <c:pt idx="29">
                  <c:v>0</c:v>
                </c:pt>
                <c:pt idx="30">
                  <c:v>8.8388954702285307</c:v>
                </c:pt>
                <c:pt idx="31">
                  <c:v>0.70777688565466002</c:v>
                </c:pt>
                <c:pt idx="32">
                  <c:v>13.2120283008831</c:v>
                </c:pt>
                <c:pt idx="33">
                  <c:v>7.5337746660749296</c:v>
                </c:pt>
                <c:pt idx="34">
                  <c:v>9.5478216569543601</c:v>
                </c:pt>
                <c:pt idx="35">
                  <c:v>9.2729521926642509</c:v>
                </c:pt>
                <c:pt idx="36">
                  <c:v>5.1842609142383296</c:v>
                </c:pt>
                <c:pt idx="37">
                  <c:v>5.42836140645045</c:v>
                </c:pt>
                <c:pt idx="38">
                  <c:v>21.237130493468101</c:v>
                </c:pt>
                <c:pt idx="39">
                  <c:v>0</c:v>
                </c:pt>
                <c:pt idx="40">
                  <c:v>7.7263423721361502</c:v>
                </c:pt>
                <c:pt idx="41">
                  <c:v>6.1964676920063297</c:v>
                </c:pt>
                <c:pt idx="42">
                  <c:v>12.7018193906531</c:v>
                </c:pt>
                <c:pt idx="43">
                  <c:v>6.0743620766265698</c:v>
                </c:pt>
                <c:pt idx="44">
                  <c:v>5.3563667403373101</c:v>
                </c:pt>
                <c:pt idx="45">
                  <c:v>7.0301857164500996</c:v>
                </c:pt>
                <c:pt idx="46">
                  <c:v>16.109918226400001</c:v>
                </c:pt>
                <c:pt idx="47">
                  <c:v>6.4714069463276704</c:v>
                </c:pt>
                <c:pt idx="48">
                  <c:v>8.1616779545602807</c:v>
                </c:pt>
                <c:pt idx="49">
                  <c:v>22.2084484686462</c:v>
                </c:pt>
                <c:pt idx="50">
                  <c:v>4.8244686641863597</c:v>
                </c:pt>
                <c:pt idx="51">
                  <c:v>4.4888400281741996</c:v>
                </c:pt>
                <c:pt idx="52">
                  <c:v>7.1043479333386701</c:v>
                </c:pt>
                <c:pt idx="53">
                  <c:v>14.671874447820301</c:v>
                </c:pt>
                <c:pt idx="54">
                  <c:v>9.7754019910630792</c:v>
                </c:pt>
                <c:pt idx="55">
                  <c:v>5.34605279279707</c:v>
                </c:pt>
                <c:pt idx="56">
                  <c:v>3.9279977761416198</c:v>
                </c:pt>
                <c:pt idx="57">
                  <c:v>8.4115948351175103</c:v>
                </c:pt>
                <c:pt idx="58">
                  <c:v>7.9394766428040899</c:v>
                </c:pt>
                <c:pt idx="59">
                  <c:v>8.6761199635594899</c:v>
                </c:pt>
                <c:pt idx="60">
                  <c:v>4.3742372622388102</c:v>
                </c:pt>
                <c:pt idx="61">
                  <c:v>6.2729831581249602</c:v>
                </c:pt>
                <c:pt idx="62">
                  <c:v>2.9818265998698901</c:v>
                </c:pt>
                <c:pt idx="63">
                  <c:v>6.7408897350229999</c:v>
                </c:pt>
                <c:pt idx="64">
                  <c:v>6.2956144996732704</c:v>
                </c:pt>
                <c:pt idx="65">
                  <c:v>5.4576464680226202</c:v>
                </c:pt>
                <c:pt idx="66">
                  <c:v>1.8723853531555299</c:v>
                </c:pt>
                <c:pt idx="67">
                  <c:v>1.23517998748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C2A-4A5F-A4E5-01564DB0C2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114269905"/>
        <c:axId val="329142843"/>
      </c:barChart>
      <c:catAx>
        <c:axId val="114269905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329142843"/>
        <c:crosses val="autoZero"/>
        <c:auto val="1"/>
        <c:lblAlgn val="ctr"/>
        <c:lblOffset val="100"/>
        <c:noMultiLvlLbl val="0"/>
      </c:catAx>
      <c:valAx>
        <c:axId val="329142843"/>
        <c:scaling>
          <c:orientation val="minMax"/>
        </c:scaling>
        <c:delete val="0"/>
        <c:axPos val="l"/>
        <c:numFmt formatCode="0.0;[Red]0.0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050" b="1" i="0" u="none" strike="noStrike" kern="1200" baseline="0">
                <a:ln>
                  <a:noFill/>
                </a:ln>
                <a:solidFill>
                  <a:schemeClr val="tx1"/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zh-CN"/>
          </a:p>
        </c:txPr>
        <c:crossAx val="114269905"/>
        <c:crosses val="autoZero"/>
        <c:crossBetween val="between"/>
        <c:majorUnit val="5"/>
      </c:valAx>
      <c:spPr>
        <a:noFill/>
        <a:ln w="12700" cmpd="sng">
          <a:noFill/>
          <a:prstDash val="solid"/>
        </a:ln>
        <a:effectLst/>
      </c:spPr>
    </c:plotArea>
    <c:legend>
      <c:legendPos val="t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chemeClr val="tx1"/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zh-CN"/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1400" b="0" i="0" u="none" strike="noStrike" kern="1200" baseline="0">
                <a:solidFill>
                  <a:schemeClr val="tx1"/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5279629864727714"/>
          <c:y val="2.1834219890922817E-2"/>
          <c:w val="0.47043981755653125"/>
          <c:h val="0.15735127357060072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1400" b="0" i="0" u="none" strike="noStrike" kern="1200" baseline="0">
              <a:solidFill>
                <a:schemeClr val="tx1"/>
              </a:solidFill>
              <a:latin typeface="Times New Roman" panose="02020603050405020304" charset="0"/>
              <a:ea typeface="+mn-ea"/>
              <a:cs typeface="Times New Roman" panose="0202060305040502030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Flavanone rutinoside</c:f>
              <c:strCache>
                <c:ptCount val="1"/>
                <c:pt idx="0">
                  <c:v>Flavanone rutinosid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比例!$A$5:$A$72</c:f>
              <c:strCache>
                <c:ptCount val="68"/>
                <c:pt idx="0">
                  <c:v>HJ</c:v>
                </c:pt>
                <c:pt idx="1">
                  <c:v>ZK</c:v>
                </c:pt>
                <c:pt idx="2">
                  <c:v>ZJ72</c:v>
                </c:pt>
                <c:pt idx="3">
                  <c:v>ZJ80</c:v>
                </c:pt>
                <c:pt idx="4">
                  <c:v>ZJ58</c:v>
                </c:pt>
                <c:pt idx="5">
                  <c:v>ZJ54</c:v>
                </c:pt>
                <c:pt idx="6">
                  <c:v>ZJ56</c:v>
                </c:pt>
                <c:pt idx="7">
                  <c:v>ZJ7</c:v>
                </c:pt>
                <c:pt idx="8">
                  <c:v>ZJ97</c:v>
                </c:pt>
                <c:pt idx="9">
                  <c:v>ZJ10</c:v>
                </c:pt>
                <c:pt idx="10">
                  <c:v>ZJ41</c:v>
                </c:pt>
                <c:pt idx="11">
                  <c:v>ZJ71</c:v>
                </c:pt>
                <c:pt idx="12">
                  <c:v>ZJ1</c:v>
                </c:pt>
                <c:pt idx="13">
                  <c:v>ZJ50</c:v>
                </c:pt>
                <c:pt idx="14">
                  <c:v>ZJ26</c:v>
                </c:pt>
                <c:pt idx="15">
                  <c:v>ZJ16</c:v>
                </c:pt>
                <c:pt idx="16">
                  <c:v>ZJ20</c:v>
                </c:pt>
                <c:pt idx="17">
                  <c:v>ZJ82</c:v>
                </c:pt>
                <c:pt idx="18">
                  <c:v>ZJ84</c:v>
                </c:pt>
                <c:pt idx="19">
                  <c:v>ZJ61</c:v>
                </c:pt>
                <c:pt idx="20">
                  <c:v>ZJ63</c:v>
                </c:pt>
                <c:pt idx="21">
                  <c:v>ZJ33</c:v>
                </c:pt>
                <c:pt idx="22">
                  <c:v>ZJ49</c:v>
                </c:pt>
                <c:pt idx="23">
                  <c:v>ZJ29</c:v>
                </c:pt>
                <c:pt idx="24">
                  <c:v>ZJ25</c:v>
                </c:pt>
                <c:pt idx="25">
                  <c:v>ZJ22</c:v>
                </c:pt>
                <c:pt idx="26">
                  <c:v>ZJ37</c:v>
                </c:pt>
                <c:pt idx="27">
                  <c:v>ZJ77</c:v>
                </c:pt>
                <c:pt idx="28">
                  <c:v>ZJ40</c:v>
                </c:pt>
                <c:pt idx="29">
                  <c:v>ZJ85</c:v>
                </c:pt>
                <c:pt idx="30">
                  <c:v>ZJ21</c:v>
                </c:pt>
                <c:pt idx="31">
                  <c:v>ZJ60</c:v>
                </c:pt>
                <c:pt idx="32">
                  <c:v>ZJ31</c:v>
                </c:pt>
                <c:pt idx="33">
                  <c:v>ZJ96</c:v>
                </c:pt>
                <c:pt idx="34">
                  <c:v>ZJ106</c:v>
                </c:pt>
                <c:pt idx="35">
                  <c:v>ZJ87</c:v>
                </c:pt>
                <c:pt idx="36">
                  <c:v>ZJ19</c:v>
                </c:pt>
                <c:pt idx="37">
                  <c:v>ZJ27</c:v>
                </c:pt>
                <c:pt idx="38">
                  <c:v>ZJ62</c:v>
                </c:pt>
                <c:pt idx="39">
                  <c:v>ZJ39</c:v>
                </c:pt>
                <c:pt idx="40">
                  <c:v>ZJ89</c:v>
                </c:pt>
                <c:pt idx="41">
                  <c:v>ZJ14</c:v>
                </c:pt>
                <c:pt idx="42">
                  <c:v>ZJ79</c:v>
                </c:pt>
                <c:pt idx="43">
                  <c:v>ZJ102</c:v>
                </c:pt>
                <c:pt idx="44">
                  <c:v>ZJ11</c:v>
                </c:pt>
                <c:pt idx="45">
                  <c:v>ZJ9</c:v>
                </c:pt>
                <c:pt idx="46">
                  <c:v>ZJ90</c:v>
                </c:pt>
                <c:pt idx="47">
                  <c:v>ZJ81</c:v>
                </c:pt>
                <c:pt idx="48">
                  <c:v>ZJ104</c:v>
                </c:pt>
                <c:pt idx="49">
                  <c:v>ZJ47</c:v>
                </c:pt>
                <c:pt idx="50">
                  <c:v>ZJ5</c:v>
                </c:pt>
                <c:pt idx="51">
                  <c:v>ZJ34</c:v>
                </c:pt>
                <c:pt idx="52">
                  <c:v>ZJ55</c:v>
                </c:pt>
                <c:pt idx="53">
                  <c:v>ZJ95</c:v>
                </c:pt>
                <c:pt idx="54">
                  <c:v>ZJ109</c:v>
                </c:pt>
                <c:pt idx="55">
                  <c:v>ZJ30</c:v>
                </c:pt>
                <c:pt idx="56">
                  <c:v>ZJ66</c:v>
                </c:pt>
                <c:pt idx="57">
                  <c:v>ZJ99</c:v>
                </c:pt>
                <c:pt idx="58">
                  <c:v>ZJ59</c:v>
                </c:pt>
                <c:pt idx="59">
                  <c:v>ZJ98</c:v>
                </c:pt>
                <c:pt idx="60">
                  <c:v>ZJ35</c:v>
                </c:pt>
                <c:pt idx="61">
                  <c:v>ZJ57</c:v>
                </c:pt>
                <c:pt idx="62">
                  <c:v>ZJ36</c:v>
                </c:pt>
                <c:pt idx="63">
                  <c:v>ZJ70</c:v>
                </c:pt>
                <c:pt idx="64">
                  <c:v>ZJ108</c:v>
                </c:pt>
                <c:pt idx="65">
                  <c:v>ZJ2</c:v>
                </c:pt>
                <c:pt idx="66">
                  <c:v>ZJ67</c:v>
                </c:pt>
                <c:pt idx="67">
                  <c:v>ZJ73</c:v>
                </c:pt>
              </c:strCache>
            </c:strRef>
          </c:cat>
          <c:val>
            <c:numRef>
              <c:f>比例!$B$5:$B$72</c:f>
              <c:numCache>
                <c:formatCode>0.00;[Red]0.00</c:formatCode>
                <c:ptCount val="68"/>
                <c:pt idx="0">
                  <c:v>10.0647863527679</c:v>
                </c:pt>
                <c:pt idx="1">
                  <c:v>3.3989128453666</c:v>
                </c:pt>
                <c:pt idx="2">
                  <c:v>21.6375751431592</c:v>
                </c:pt>
                <c:pt idx="3">
                  <c:v>19.376466592793701</c:v>
                </c:pt>
                <c:pt idx="4">
                  <c:v>19.375948345003099</c:v>
                </c:pt>
                <c:pt idx="5">
                  <c:v>18.864819850517101</c:v>
                </c:pt>
                <c:pt idx="6">
                  <c:v>16.306089814448899</c:v>
                </c:pt>
                <c:pt idx="7">
                  <c:v>15.8314091684743</c:v>
                </c:pt>
                <c:pt idx="8">
                  <c:v>15.275341468762599</c:v>
                </c:pt>
                <c:pt idx="9">
                  <c:v>15.0147662739474</c:v>
                </c:pt>
                <c:pt idx="10">
                  <c:v>14.117532281898299</c:v>
                </c:pt>
                <c:pt idx="11">
                  <c:v>14.040037253478101</c:v>
                </c:pt>
                <c:pt idx="12">
                  <c:v>13.955556874229099</c:v>
                </c:pt>
                <c:pt idx="13">
                  <c:v>13.358559132248599</c:v>
                </c:pt>
                <c:pt idx="14">
                  <c:v>13.1095400336695</c:v>
                </c:pt>
                <c:pt idx="15">
                  <c:v>12.643951087521501</c:v>
                </c:pt>
                <c:pt idx="16">
                  <c:v>12.642121949117101</c:v>
                </c:pt>
                <c:pt idx="17">
                  <c:v>12.5301223101979</c:v>
                </c:pt>
                <c:pt idx="18">
                  <c:v>12.3629923439586</c:v>
                </c:pt>
                <c:pt idx="19">
                  <c:v>11.613086149986399</c:v>
                </c:pt>
                <c:pt idx="20">
                  <c:v>11.156128613983</c:v>
                </c:pt>
                <c:pt idx="21">
                  <c:v>11.1193663392754</c:v>
                </c:pt>
                <c:pt idx="22">
                  <c:v>10.775088643048599</c:v>
                </c:pt>
                <c:pt idx="23">
                  <c:v>10.6121452308484</c:v>
                </c:pt>
                <c:pt idx="24">
                  <c:v>10.4975192417696</c:v>
                </c:pt>
                <c:pt idx="25">
                  <c:v>9.5181599961844991</c:v>
                </c:pt>
                <c:pt idx="26">
                  <c:v>8.8097894167817294</c:v>
                </c:pt>
                <c:pt idx="27">
                  <c:v>8.5333789252627898</c:v>
                </c:pt>
                <c:pt idx="28">
                  <c:v>6.6767143672021998</c:v>
                </c:pt>
                <c:pt idx="29">
                  <c:v>6.3491862628865201</c:v>
                </c:pt>
                <c:pt idx="30">
                  <c:v>5.8506293226402404</c:v>
                </c:pt>
                <c:pt idx="31">
                  <c:v>5.6038218850408104</c:v>
                </c:pt>
                <c:pt idx="32">
                  <c:v>5.2897705239016597</c:v>
                </c:pt>
                <c:pt idx="33">
                  <c:v>4.6276123830421501</c:v>
                </c:pt>
                <c:pt idx="34">
                  <c:v>4.1295800131482903</c:v>
                </c:pt>
                <c:pt idx="35">
                  <c:v>4.0428335367242196</c:v>
                </c:pt>
                <c:pt idx="36">
                  <c:v>3.9959339013053201</c:v>
                </c:pt>
                <c:pt idx="37">
                  <c:v>3.9779120036478401</c:v>
                </c:pt>
                <c:pt idx="38">
                  <c:v>3.9550165734342002</c:v>
                </c:pt>
                <c:pt idx="39">
                  <c:v>3.9503551343741798</c:v>
                </c:pt>
                <c:pt idx="40">
                  <c:v>3.8994816353856101</c:v>
                </c:pt>
                <c:pt idx="41">
                  <c:v>3.8470656757490498</c:v>
                </c:pt>
                <c:pt idx="42">
                  <c:v>3.8332551239335602</c:v>
                </c:pt>
                <c:pt idx="43">
                  <c:v>3.7154785689635199</c:v>
                </c:pt>
                <c:pt idx="44">
                  <c:v>3.6901735863075902</c:v>
                </c:pt>
                <c:pt idx="45">
                  <c:v>3.4841340367540701</c:v>
                </c:pt>
                <c:pt idx="46">
                  <c:v>3.4808075578310902</c:v>
                </c:pt>
                <c:pt idx="47">
                  <c:v>3.3007745609125898</c:v>
                </c:pt>
                <c:pt idx="48">
                  <c:v>3.27223325134212</c:v>
                </c:pt>
                <c:pt idx="49">
                  <c:v>3.1517089177087301</c:v>
                </c:pt>
                <c:pt idx="50">
                  <c:v>2.9472373644495802</c:v>
                </c:pt>
                <c:pt idx="51">
                  <c:v>2.8688474326986499</c:v>
                </c:pt>
                <c:pt idx="52">
                  <c:v>2.8671481629246101</c:v>
                </c:pt>
                <c:pt idx="53">
                  <c:v>2.7375712197859299</c:v>
                </c:pt>
                <c:pt idx="54">
                  <c:v>2.6411225307154198</c:v>
                </c:pt>
                <c:pt idx="55">
                  <c:v>2.60608461042793</c:v>
                </c:pt>
                <c:pt idx="56">
                  <c:v>2.59002129923697</c:v>
                </c:pt>
                <c:pt idx="57">
                  <c:v>2.5417188424675801</c:v>
                </c:pt>
                <c:pt idx="58">
                  <c:v>2.5155458604361498</c:v>
                </c:pt>
                <c:pt idx="59">
                  <c:v>2.4947055398194</c:v>
                </c:pt>
                <c:pt idx="60">
                  <c:v>2.3636918155726399</c:v>
                </c:pt>
                <c:pt idx="61">
                  <c:v>2.3608552995096499</c:v>
                </c:pt>
                <c:pt idx="62">
                  <c:v>2.3580542096671402</c:v>
                </c:pt>
                <c:pt idx="63">
                  <c:v>2.22591414871814</c:v>
                </c:pt>
                <c:pt idx="64">
                  <c:v>2.1868119203446801</c:v>
                </c:pt>
                <c:pt idx="65">
                  <c:v>2.1669679932618302</c:v>
                </c:pt>
                <c:pt idx="66">
                  <c:v>2.0911053391640602</c:v>
                </c:pt>
                <c:pt idx="67">
                  <c:v>1.8616574687215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83-4EEE-AC9C-228134926C00}"/>
            </c:ext>
          </c:extLst>
        </c:ser>
        <c:ser>
          <c:idx val="1"/>
          <c:order val="1"/>
          <c:tx>
            <c:strRef>
              <c:f>Flavanone neohesperidoside</c:f>
              <c:strCache>
                <c:ptCount val="1"/>
                <c:pt idx="0">
                  <c:v>Flavanone neohesperidosid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比例!$A$5:$A$72</c:f>
              <c:strCache>
                <c:ptCount val="68"/>
                <c:pt idx="0">
                  <c:v>HJ</c:v>
                </c:pt>
                <c:pt idx="1">
                  <c:v>ZK</c:v>
                </c:pt>
                <c:pt idx="2">
                  <c:v>ZJ72</c:v>
                </c:pt>
                <c:pt idx="3">
                  <c:v>ZJ80</c:v>
                </c:pt>
                <c:pt idx="4">
                  <c:v>ZJ58</c:v>
                </c:pt>
                <c:pt idx="5">
                  <c:v>ZJ54</c:v>
                </c:pt>
                <c:pt idx="6">
                  <c:v>ZJ56</c:v>
                </c:pt>
                <c:pt idx="7">
                  <c:v>ZJ7</c:v>
                </c:pt>
                <c:pt idx="8">
                  <c:v>ZJ97</c:v>
                </c:pt>
                <c:pt idx="9">
                  <c:v>ZJ10</c:v>
                </c:pt>
                <c:pt idx="10">
                  <c:v>ZJ41</c:v>
                </c:pt>
                <c:pt idx="11">
                  <c:v>ZJ71</c:v>
                </c:pt>
                <c:pt idx="12">
                  <c:v>ZJ1</c:v>
                </c:pt>
                <c:pt idx="13">
                  <c:v>ZJ50</c:v>
                </c:pt>
                <c:pt idx="14">
                  <c:v>ZJ26</c:v>
                </c:pt>
                <c:pt idx="15">
                  <c:v>ZJ16</c:v>
                </c:pt>
                <c:pt idx="16">
                  <c:v>ZJ20</c:v>
                </c:pt>
                <c:pt idx="17">
                  <c:v>ZJ82</c:v>
                </c:pt>
                <c:pt idx="18">
                  <c:v>ZJ84</c:v>
                </c:pt>
                <c:pt idx="19">
                  <c:v>ZJ61</c:v>
                </c:pt>
                <c:pt idx="20">
                  <c:v>ZJ63</c:v>
                </c:pt>
                <c:pt idx="21">
                  <c:v>ZJ33</c:v>
                </c:pt>
                <c:pt idx="22">
                  <c:v>ZJ49</c:v>
                </c:pt>
                <c:pt idx="23">
                  <c:v>ZJ29</c:v>
                </c:pt>
                <c:pt idx="24">
                  <c:v>ZJ25</c:v>
                </c:pt>
                <c:pt idx="25">
                  <c:v>ZJ22</c:v>
                </c:pt>
                <c:pt idx="26">
                  <c:v>ZJ37</c:v>
                </c:pt>
                <c:pt idx="27">
                  <c:v>ZJ77</c:v>
                </c:pt>
                <c:pt idx="28">
                  <c:v>ZJ40</c:v>
                </c:pt>
                <c:pt idx="29">
                  <c:v>ZJ85</c:v>
                </c:pt>
                <c:pt idx="30">
                  <c:v>ZJ21</c:v>
                </c:pt>
                <c:pt idx="31">
                  <c:v>ZJ60</c:v>
                </c:pt>
                <c:pt idx="32">
                  <c:v>ZJ31</c:v>
                </c:pt>
                <c:pt idx="33">
                  <c:v>ZJ96</c:v>
                </c:pt>
                <c:pt idx="34">
                  <c:v>ZJ106</c:v>
                </c:pt>
                <c:pt idx="35">
                  <c:v>ZJ87</c:v>
                </c:pt>
                <c:pt idx="36">
                  <c:v>ZJ19</c:v>
                </c:pt>
                <c:pt idx="37">
                  <c:v>ZJ27</c:v>
                </c:pt>
                <c:pt idx="38">
                  <c:v>ZJ62</c:v>
                </c:pt>
                <c:pt idx="39">
                  <c:v>ZJ39</c:v>
                </c:pt>
                <c:pt idx="40">
                  <c:v>ZJ89</c:v>
                </c:pt>
                <c:pt idx="41">
                  <c:v>ZJ14</c:v>
                </c:pt>
                <c:pt idx="42">
                  <c:v>ZJ79</c:v>
                </c:pt>
                <c:pt idx="43">
                  <c:v>ZJ102</c:v>
                </c:pt>
                <c:pt idx="44">
                  <c:v>ZJ11</c:v>
                </c:pt>
                <c:pt idx="45">
                  <c:v>ZJ9</c:v>
                </c:pt>
                <c:pt idx="46">
                  <c:v>ZJ90</c:v>
                </c:pt>
                <c:pt idx="47">
                  <c:v>ZJ81</c:v>
                </c:pt>
                <c:pt idx="48">
                  <c:v>ZJ104</c:v>
                </c:pt>
                <c:pt idx="49">
                  <c:v>ZJ47</c:v>
                </c:pt>
                <c:pt idx="50">
                  <c:v>ZJ5</c:v>
                </c:pt>
                <c:pt idx="51">
                  <c:v>ZJ34</c:v>
                </c:pt>
                <c:pt idx="52">
                  <c:v>ZJ55</c:v>
                </c:pt>
                <c:pt idx="53">
                  <c:v>ZJ95</c:v>
                </c:pt>
                <c:pt idx="54">
                  <c:v>ZJ109</c:v>
                </c:pt>
                <c:pt idx="55">
                  <c:v>ZJ30</c:v>
                </c:pt>
                <c:pt idx="56">
                  <c:v>ZJ66</c:v>
                </c:pt>
                <c:pt idx="57">
                  <c:v>ZJ99</c:v>
                </c:pt>
                <c:pt idx="58">
                  <c:v>ZJ59</c:v>
                </c:pt>
                <c:pt idx="59">
                  <c:v>ZJ98</c:v>
                </c:pt>
                <c:pt idx="60">
                  <c:v>ZJ35</c:v>
                </c:pt>
                <c:pt idx="61">
                  <c:v>ZJ57</c:v>
                </c:pt>
                <c:pt idx="62">
                  <c:v>ZJ36</c:v>
                </c:pt>
                <c:pt idx="63">
                  <c:v>ZJ70</c:v>
                </c:pt>
                <c:pt idx="64">
                  <c:v>ZJ108</c:v>
                </c:pt>
                <c:pt idx="65">
                  <c:v>ZJ2</c:v>
                </c:pt>
                <c:pt idx="66">
                  <c:v>ZJ67</c:v>
                </c:pt>
                <c:pt idx="67">
                  <c:v>ZJ73</c:v>
                </c:pt>
              </c:strCache>
            </c:strRef>
          </c:cat>
          <c:val>
            <c:numRef>
              <c:f>比例!$C$5:$C$72</c:f>
              <c:numCache>
                <c:formatCode>0.00;[Red]0.00</c:formatCode>
                <c:ptCount val="68"/>
                <c:pt idx="0">
                  <c:v>0</c:v>
                </c:pt>
                <c:pt idx="1">
                  <c:v>11.65332787170840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29486465251607802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.48973320870928</c:v>
                </c:pt>
                <c:pt idx="28">
                  <c:v>0</c:v>
                </c:pt>
                <c:pt idx="29">
                  <c:v>0</c:v>
                </c:pt>
                <c:pt idx="30">
                  <c:v>8.8388954702285307</c:v>
                </c:pt>
                <c:pt idx="31">
                  <c:v>0.70777688565466002</c:v>
                </c:pt>
                <c:pt idx="32">
                  <c:v>13.2120283008831</c:v>
                </c:pt>
                <c:pt idx="33">
                  <c:v>7.5337746660749296</c:v>
                </c:pt>
                <c:pt idx="34">
                  <c:v>9.5478216569543601</c:v>
                </c:pt>
                <c:pt idx="35">
                  <c:v>9.2729521926642509</c:v>
                </c:pt>
                <c:pt idx="36">
                  <c:v>5.1842609142383296</c:v>
                </c:pt>
                <c:pt idx="37">
                  <c:v>5.42836140645045</c:v>
                </c:pt>
                <c:pt idx="38">
                  <c:v>21.237130493468101</c:v>
                </c:pt>
                <c:pt idx="39">
                  <c:v>0</c:v>
                </c:pt>
                <c:pt idx="40">
                  <c:v>7.7263423721361502</c:v>
                </c:pt>
                <c:pt idx="41">
                  <c:v>6.1964676920063297</c:v>
                </c:pt>
                <c:pt idx="42">
                  <c:v>12.7018193906531</c:v>
                </c:pt>
                <c:pt idx="43">
                  <c:v>6.0743620766265698</c:v>
                </c:pt>
                <c:pt idx="44">
                  <c:v>5.3563667403373101</c:v>
                </c:pt>
                <c:pt idx="45">
                  <c:v>7.0301857164500996</c:v>
                </c:pt>
                <c:pt idx="46">
                  <c:v>16.109918226400001</c:v>
                </c:pt>
                <c:pt idx="47">
                  <c:v>6.4714069463276704</c:v>
                </c:pt>
                <c:pt idx="48">
                  <c:v>8.1616779545602807</c:v>
                </c:pt>
                <c:pt idx="49">
                  <c:v>22.2084484686462</c:v>
                </c:pt>
                <c:pt idx="50">
                  <c:v>4.8244686641863597</c:v>
                </c:pt>
                <c:pt idx="51">
                  <c:v>4.4888400281741996</c:v>
                </c:pt>
                <c:pt idx="52">
                  <c:v>7.1043479333386701</c:v>
                </c:pt>
                <c:pt idx="53">
                  <c:v>14.671874447820301</c:v>
                </c:pt>
                <c:pt idx="54">
                  <c:v>9.7754019910630792</c:v>
                </c:pt>
                <c:pt idx="55">
                  <c:v>5.34605279279707</c:v>
                </c:pt>
                <c:pt idx="56">
                  <c:v>3.9279977761416198</c:v>
                </c:pt>
                <c:pt idx="57">
                  <c:v>8.4115948351175103</c:v>
                </c:pt>
                <c:pt idx="58">
                  <c:v>7.9394766428040899</c:v>
                </c:pt>
                <c:pt idx="59">
                  <c:v>8.6761199635594899</c:v>
                </c:pt>
                <c:pt idx="60">
                  <c:v>4.3742372622388102</c:v>
                </c:pt>
                <c:pt idx="61">
                  <c:v>6.2729831581249602</c:v>
                </c:pt>
                <c:pt idx="62">
                  <c:v>2.9818265998698901</c:v>
                </c:pt>
                <c:pt idx="63">
                  <c:v>6.7408897350229999</c:v>
                </c:pt>
                <c:pt idx="64">
                  <c:v>6.2956144996732704</c:v>
                </c:pt>
                <c:pt idx="65">
                  <c:v>5.4576464680226202</c:v>
                </c:pt>
                <c:pt idx="66">
                  <c:v>1.8723853531555299</c:v>
                </c:pt>
                <c:pt idx="67">
                  <c:v>1.235179987482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83-4EEE-AC9C-228134926C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116615936"/>
        <c:axId val="116612608"/>
      </c:barChart>
      <c:catAx>
        <c:axId val="116615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zh-CN"/>
          </a:p>
        </c:txPr>
        <c:crossAx val="116612608"/>
        <c:crosses val="autoZero"/>
        <c:auto val="1"/>
        <c:lblAlgn val="ctr"/>
        <c:lblOffset val="150"/>
        <c:noMultiLvlLbl val="0"/>
      </c:catAx>
      <c:valAx>
        <c:axId val="116612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charset="0"/>
                <a:ea typeface="+mn-ea"/>
                <a:cs typeface="Times New Roman" panose="02020603050405020304" charset="0"/>
              </a:defRPr>
            </a:pPr>
            <a:endParaRPr lang="zh-CN"/>
          </a:p>
        </c:txPr>
        <c:crossAx val="11661593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9.7745267913934161E-2"/>
          <c:y val="0.13240291959971434"/>
          <c:w val="0.90058298423003447"/>
          <c:h val="0.66354117396102874"/>
        </c:manualLayout>
      </c:layout>
      <c:barChart>
        <c:barDir val="col"/>
        <c:grouping val="percentStacked"/>
        <c:varyColors val="0"/>
        <c:ser>
          <c:idx val="0"/>
          <c:order val="0"/>
          <c:tx>
            <c:v>Flavanone rutinoside</c:v>
          </c:tx>
          <c:spPr>
            <a:solidFill>
              <a:schemeClr val="tx1"/>
            </a:solidFill>
          </c:spPr>
          <c:invertIfNegative val="0"/>
          <c:cat>
            <c:strRef>
              <c:f>总表!$A$48:$A$86</c:f>
              <c:strCache>
                <c:ptCount val="39"/>
                <c:pt idx="0">
                  <c:v>HB</c:v>
                </c:pt>
                <c:pt idx="1">
                  <c:v>FC</c:v>
                </c:pt>
                <c:pt idx="2">
                  <c:v>HFL6</c:v>
                </c:pt>
                <c:pt idx="3">
                  <c:v>HFL7</c:v>
                </c:pt>
                <c:pt idx="4">
                  <c:v>HFw1</c:v>
                </c:pt>
                <c:pt idx="5">
                  <c:v>HFW2</c:v>
                </c:pt>
                <c:pt idx="6">
                  <c:v>HF7</c:v>
                </c:pt>
                <c:pt idx="7">
                  <c:v>HF30</c:v>
                </c:pt>
                <c:pt idx="8">
                  <c:v>HF39</c:v>
                </c:pt>
                <c:pt idx="9">
                  <c:v>HF59</c:v>
                </c:pt>
                <c:pt idx="10">
                  <c:v>HF63</c:v>
                </c:pt>
                <c:pt idx="11">
                  <c:v>HF75</c:v>
                </c:pt>
                <c:pt idx="12">
                  <c:v>HF78</c:v>
                </c:pt>
                <c:pt idx="13">
                  <c:v>HF80</c:v>
                </c:pt>
                <c:pt idx="14">
                  <c:v>HF82</c:v>
                </c:pt>
                <c:pt idx="15">
                  <c:v>HF88</c:v>
                </c:pt>
                <c:pt idx="16">
                  <c:v>HF108</c:v>
                </c:pt>
                <c:pt idx="17">
                  <c:v>HF111</c:v>
                </c:pt>
                <c:pt idx="18">
                  <c:v>HF112</c:v>
                </c:pt>
                <c:pt idx="19">
                  <c:v>HF149</c:v>
                </c:pt>
                <c:pt idx="20">
                  <c:v>HF150</c:v>
                </c:pt>
                <c:pt idx="21">
                  <c:v>HF154</c:v>
                </c:pt>
                <c:pt idx="22">
                  <c:v>HF156</c:v>
                </c:pt>
                <c:pt idx="23">
                  <c:v>HF159</c:v>
                </c:pt>
                <c:pt idx="24">
                  <c:v>HF165</c:v>
                </c:pt>
                <c:pt idx="25">
                  <c:v>HF168</c:v>
                </c:pt>
                <c:pt idx="26">
                  <c:v>HF170</c:v>
                </c:pt>
                <c:pt idx="27">
                  <c:v>HF172</c:v>
                </c:pt>
                <c:pt idx="28">
                  <c:v>HF187</c:v>
                </c:pt>
                <c:pt idx="29">
                  <c:v>HF188</c:v>
                </c:pt>
                <c:pt idx="30">
                  <c:v>HF197</c:v>
                </c:pt>
                <c:pt idx="31">
                  <c:v>HF198</c:v>
                </c:pt>
                <c:pt idx="32">
                  <c:v>HF203</c:v>
                </c:pt>
                <c:pt idx="33">
                  <c:v>HF204</c:v>
                </c:pt>
                <c:pt idx="34">
                  <c:v>HF205</c:v>
                </c:pt>
                <c:pt idx="35">
                  <c:v>HF208</c:v>
                </c:pt>
                <c:pt idx="36">
                  <c:v>HF210</c:v>
                </c:pt>
                <c:pt idx="37">
                  <c:v>HF213</c:v>
                </c:pt>
                <c:pt idx="38">
                  <c:v>HF214</c:v>
                </c:pt>
              </c:strCache>
            </c:strRef>
          </c:cat>
          <c:val>
            <c:numRef>
              <c:f>总表!$B$48:$B$86</c:f>
              <c:numCache>
                <c:formatCode>0.00;[Red]0.00</c:formatCode>
                <c:ptCount val="39"/>
                <c:pt idx="0" formatCode="General">
                  <c:v>0</c:v>
                </c:pt>
                <c:pt idx="1">
                  <c:v>27.183351866347</c:v>
                </c:pt>
                <c:pt idx="2" formatCode="0.00_ ">
                  <c:v>1.7789131960972675</c:v>
                </c:pt>
                <c:pt idx="3" formatCode="0.00_ ">
                  <c:v>2.7717516722327402</c:v>
                </c:pt>
                <c:pt idx="4" formatCode="0.00_ ">
                  <c:v>5.6031529356305247</c:v>
                </c:pt>
                <c:pt idx="5" formatCode="0.00_ ">
                  <c:v>2.6143687355922141</c:v>
                </c:pt>
                <c:pt idx="6" formatCode="0.00_ ">
                  <c:v>3.0171023589746646</c:v>
                </c:pt>
                <c:pt idx="7" formatCode="0.00_ ">
                  <c:v>2.4312228191624192</c:v>
                </c:pt>
                <c:pt idx="8" formatCode="0.00_ ">
                  <c:v>2.7629003229322158</c:v>
                </c:pt>
                <c:pt idx="9" formatCode="0.00_ ">
                  <c:v>5.2215553597322382</c:v>
                </c:pt>
                <c:pt idx="10" formatCode="0.00_ ">
                  <c:v>1.1345095827780487</c:v>
                </c:pt>
                <c:pt idx="11" formatCode="0.00_ ">
                  <c:v>1.4221224847896983</c:v>
                </c:pt>
                <c:pt idx="12" formatCode="0.00_ ">
                  <c:v>1.6554656714839389</c:v>
                </c:pt>
                <c:pt idx="13" formatCode="0.00_ ">
                  <c:v>1.3882442811648474</c:v>
                </c:pt>
                <c:pt idx="14" formatCode="0.00_ ">
                  <c:v>3.0217738890161776</c:v>
                </c:pt>
                <c:pt idx="15" formatCode="0.00_ ">
                  <c:v>1.372552563675014</c:v>
                </c:pt>
                <c:pt idx="16" formatCode="0.00_ ">
                  <c:v>1.4953774919902063</c:v>
                </c:pt>
                <c:pt idx="17" formatCode="0.00_ ">
                  <c:v>2.0527669772774018</c:v>
                </c:pt>
                <c:pt idx="18" formatCode="0.00_ ">
                  <c:v>5.5346196393853999</c:v>
                </c:pt>
                <c:pt idx="19" formatCode="0.00_ ">
                  <c:v>2.0114328154646532</c:v>
                </c:pt>
                <c:pt idx="20" formatCode="0.00_ ">
                  <c:v>2.4169935607978892</c:v>
                </c:pt>
                <c:pt idx="21" formatCode="0.00_ ">
                  <c:v>2.706958696920891</c:v>
                </c:pt>
                <c:pt idx="22" formatCode="0.00_ ">
                  <c:v>1.6966863541395067</c:v>
                </c:pt>
                <c:pt idx="23" formatCode="0.00_ ">
                  <c:v>5.7132311925091557</c:v>
                </c:pt>
                <c:pt idx="24" formatCode="0.00_ ">
                  <c:v>2.6634402010725644</c:v>
                </c:pt>
                <c:pt idx="25" formatCode="0.00_ ">
                  <c:v>5.3449866024788406</c:v>
                </c:pt>
                <c:pt idx="26" formatCode="0.00_ ">
                  <c:v>1.1633797167170472</c:v>
                </c:pt>
                <c:pt idx="27" formatCode="0.00_ ">
                  <c:v>3.2974902714264656</c:v>
                </c:pt>
                <c:pt idx="28" formatCode="0.00_ ">
                  <c:v>1.6688696804200382</c:v>
                </c:pt>
                <c:pt idx="29" formatCode="0.00_ ">
                  <c:v>1.0495374574593495</c:v>
                </c:pt>
                <c:pt idx="30" formatCode="0.00_ ">
                  <c:v>2.7257688603952501</c:v>
                </c:pt>
                <c:pt idx="31" formatCode="0.00_ ">
                  <c:v>1.8550273782905793</c:v>
                </c:pt>
                <c:pt idx="32" formatCode="0.00_ ">
                  <c:v>1.2933566209523149</c:v>
                </c:pt>
                <c:pt idx="33" formatCode="0.00_ ">
                  <c:v>1.6793452788133492</c:v>
                </c:pt>
                <c:pt idx="34" formatCode="0.00_ ">
                  <c:v>1.8925285595839132</c:v>
                </c:pt>
                <c:pt idx="35" formatCode="0.00_ ">
                  <c:v>4.4768408841384959</c:v>
                </c:pt>
                <c:pt idx="36" formatCode="0.00_ ">
                  <c:v>2.1688077210714272</c:v>
                </c:pt>
                <c:pt idx="37" formatCode="0.00_ ">
                  <c:v>1.4131905114712406</c:v>
                </c:pt>
                <c:pt idx="38" formatCode="0.00_ ">
                  <c:v>1.58622949169130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24-4E8E-94D0-6C52D3EAC051}"/>
            </c:ext>
          </c:extLst>
        </c:ser>
        <c:ser>
          <c:idx val="1"/>
          <c:order val="1"/>
          <c:tx>
            <c:v>Flavanone neohesperidoside</c:v>
          </c:tx>
          <c:spPr>
            <a:solidFill>
              <a:schemeClr val="bg1">
                <a:lumMod val="65000"/>
              </a:schemeClr>
            </a:solidFill>
          </c:spPr>
          <c:invertIfNegative val="0"/>
          <c:cat>
            <c:strRef>
              <c:f>总表!$A$48:$A$86</c:f>
              <c:strCache>
                <c:ptCount val="39"/>
                <c:pt idx="0">
                  <c:v>HB</c:v>
                </c:pt>
                <c:pt idx="1">
                  <c:v>FC</c:v>
                </c:pt>
                <c:pt idx="2">
                  <c:v>HFL6</c:v>
                </c:pt>
                <c:pt idx="3">
                  <c:v>HFL7</c:v>
                </c:pt>
                <c:pt idx="4">
                  <c:v>HFw1</c:v>
                </c:pt>
                <c:pt idx="5">
                  <c:v>HFW2</c:v>
                </c:pt>
                <c:pt idx="6">
                  <c:v>HF7</c:v>
                </c:pt>
                <c:pt idx="7">
                  <c:v>HF30</c:v>
                </c:pt>
                <c:pt idx="8">
                  <c:v>HF39</c:v>
                </c:pt>
                <c:pt idx="9">
                  <c:v>HF59</c:v>
                </c:pt>
                <c:pt idx="10">
                  <c:v>HF63</c:v>
                </c:pt>
                <c:pt idx="11">
                  <c:v>HF75</c:v>
                </c:pt>
                <c:pt idx="12">
                  <c:v>HF78</c:v>
                </c:pt>
                <c:pt idx="13">
                  <c:v>HF80</c:v>
                </c:pt>
                <c:pt idx="14">
                  <c:v>HF82</c:v>
                </c:pt>
                <c:pt idx="15">
                  <c:v>HF88</c:v>
                </c:pt>
                <c:pt idx="16">
                  <c:v>HF108</c:v>
                </c:pt>
                <c:pt idx="17">
                  <c:v>HF111</c:v>
                </c:pt>
                <c:pt idx="18">
                  <c:v>HF112</c:v>
                </c:pt>
                <c:pt idx="19">
                  <c:v>HF149</c:v>
                </c:pt>
                <c:pt idx="20">
                  <c:v>HF150</c:v>
                </c:pt>
                <c:pt idx="21">
                  <c:v>HF154</c:v>
                </c:pt>
                <c:pt idx="22">
                  <c:v>HF156</c:v>
                </c:pt>
                <c:pt idx="23">
                  <c:v>HF159</c:v>
                </c:pt>
                <c:pt idx="24">
                  <c:v>HF165</c:v>
                </c:pt>
                <c:pt idx="25">
                  <c:v>HF168</c:v>
                </c:pt>
                <c:pt idx="26">
                  <c:v>HF170</c:v>
                </c:pt>
                <c:pt idx="27">
                  <c:v>HF172</c:v>
                </c:pt>
                <c:pt idx="28">
                  <c:v>HF187</c:v>
                </c:pt>
                <c:pt idx="29">
                  <c:v>HF188</c:v>
                </c:pt>
                <c:pt idx="30">
                  <c:v>HF197</c:v>
                </c:pt>
                <c:pt idx="31">
                  <c:v>HF198</c:v>
                </c:pt>
                <c:pt idx="32">
                  <c:v>HF203</c:v>
                </c:pt>
                <c:pt idx="33">
                  <c:v>HF204</c:v>
                </c:pt>
                <c:pt idx="34">
                  <c:v>HF205</c:v>
                </c:pt>
                <c:pt idx="35">
                  <c:v>HF208</c:v>
                </c:pt>
                <c:pt idx="36">
                  <c:v>HF210</c:v>
                </c:pt>
                <c:pt idx="37">
                  <c:v>HF213</c:v>
                </c:pt>
                <c:pt idx="38">
                  <c:v>HF214</c:v>
                </c:pt>
              </c:strCache>
            </c:strRef>
          </c:cat>
          <c:val>
            <c:numRef>
              <c:f>总表!$C$48:$C$86</c:f>
              <c:numCache>
                <c:formatCode>General</c:formatCode>
                <c:ptCount val="39"/>
                <c:pt idx="0" formatCode="0.00;[Red]0.00">
                  <c:v>30.094265214678586</c:v>
                </c:pt>
                <c:pt idx="1">
                  <c:v>0</c:v>
                </c:pt>
                <c:pt idx="2" formatCode="0.00;[Red]0.00">
                  <c:v>30.383823400284342</c:v>
                </c:pt>
                <c:pt idx="3" formatCode="0.00;[Red]0.00">
                  <c:v>30.575946354046138</c:v>
                </c:pt>
                <c:pt idx="4" formatCode="0.00;[Red]0.00">
                  <c:v>33.060934050888164</c:v>
                </c:pt>
                <c:pt idx="5" formatCode="0.00;[Red]0.00">
                  <c:v>9.2305363933693609</c:v>
                </c:pt>
                <c:pt idx="6" formatCode="0.00;[Red]0.00">
                  <c:v>29.123523863679882</c:v>
                </c:pt>
                <c:pt idx="7" formatCode="0.00;[Red]0.00">
                  <c:v>11.006251960839554</c:v>
                </c:pt>
                <c:pt idx="8" formatCode="0.00;[Red]0.00">
                  <c:v>8.9841850282186044</c:v>
                </c:pt>
                <c:pt idx="9" formatCode="0.00;[Red]0.00">
                  <c:v>45.862784100030069</c:v>
                </c:pt>
                <c:pt idx="10" formatCode="0.00;[Red]0.00">
                  <c:v>6.8086674516076329</c:v>
                </c:pt>
                <c:pt idx="11" formatCode="0.00;[Red]0.00">
                  <c:v>5.6242624407615986</c:v>
                </c:pt>
                <c:pt idx="12" formatCode="0.00;[Red]0.00">
                  <c:v>13.194427783522519</c:v>
                </c:pt>
                <c:pt idx="13" formatCode="0.00;[Red]0.00">
                  <c:v>8.4408636953504956</c:v>
                </c:pt>
                <c:pt idx="14" formatCode="0.00;[Red]0.00">
                  <c:v>17.4213705755175</c:v>
                </c:pt>
                <c:pt idx="15" formatCode="0.00;[Red]0.00">
                  <c:v>3.6910096649156188</c:v>
                </c:pt>
                <c:pt idx="16" formatCode="0.00;[Red]0.00">
                  <c:v>3.4555167374662905</c:v>
                </c:pt>
                <c:pt idx="17" formatCode="0.00;[Red]0.00">
                  <c:v>4.8055732950550736</c:v>
                </c:pt>
                <c:pt idx="18" formatCode="0.00;[Red]0.00">
                  <c:v>24.391902106225341</c:v>
                </c:pt>
                <c:pt idx="19" formatCode="0.00;[Red]0.00">
                  <c:v>8.3005582558807784</c:v>
                </c:pt>
                <c:pt idx="20" formatCode="0.00;[Red]0.00">
                  <c:v>13.037105682788939</c:v>
                </c:pt>
                <c:pt idx="21" formatCode="0.00;[Red]0.00">
                  <c:v>18.512170191238251</c:v>
                </c:pt>
                <c:pt idx="22" formatCode="0.00;[Red]0.00">
                  <c:v>10.065793181072854</c:v>
                </c:pt>
                <c:pt idx="23" formatCode="0.00;[Red]0.00">
                  <c:v>38.043856081875305</c:v>
                </c:pt>
                <c:pt idx="24" formatCode="0.00;[Red]0.00">
                  <c:v>10.179453606288346</c:v>
                </c:pt>
                <c:pt idx="25" formatCode="0.00;[Red]0.00">
                  <c:v>35.349288975295345</c:v>
                </c:pt>
                <c:pt idx="26" formatCode="0.00;[Red]0.00">
                  <c:v>2.8803546319724389</c:v>
                </c:pt>
                <c:pt idx="27" formatCode="0.00;[Red]0.00">
                  <c:v>24.396625454893268</c:v>
                </c:pt>
                <c:pt idx="28" formatCode="0.00;[Red]0.00">
                  <c:v>4.9181740791578408</c:v>
                </c:pt>
                <c:pt idx="29" formatCode="0.00;[Red]0.00">
                  <c:v>2.8597673418429452</c:v>
                </c:pt>
                <c:pt idx="30" formatCode="0.00;[Red]0.00">
                  <c:v>21.86501664603075</c:v>
                </c:pt>
                <c:pt idx="31" formatCode="0.00;[Red]0.00">
                  <c:v>5.4261809738575479</c:v>
                </c:pt>
                <c:pt idx="32" formatCode="0.00;[Red]0.00">
                  <c:v>7.0652421881735075</c:v>
                </c:pt>
                <c:pt idx="33" formatCode="0.00;[Red]0.00">
                  <c:v>7.5555277544153112</c:v>
                </c:pt>
                <c:pt idx="34" formatCode="0.00;[Red]0.00">
                  <c:v>6.6109937129317196</c:v>
                </c:pt>
                <c:pt idx="35" formatCode="0.00;[Red]0.00">
                  <c:v>10.356299175789241</c:v>
                </c:pt>
                <c:pt idx="36" formatCode="0.00;[Red]0.00">
                  <c:v>12.912516600265604</c:v>
                </c:pt>
                <c:pt idx="37" formatCode="0.00;[Red]0.00">
                  <c:v>3.9362395392007929</c:v>
                </c:pt>
                <c:pt idx="38" formatCode="0.00;[Red]0.00">
                  <c:v>4.06806344991252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B24-4E8E-94D0-6C52D3EAC0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162256000"/>
        <c:axId val="162257536"/>
      </c:barChart>
      <c:catAx>
        <c:axId val="162256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2257536"/>
        <c:crosses val="autoZero"/>
        <c:auto val="1"/>
        <c:lblAlgn val="ctr"/>
        <c:lblOffset val="100"/>
        <c:noMultiLvlLbl val="0"/>
      </c:catAx>
      <c:valAx>
        <c:axId val="16225753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62256000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84960593109592"/>
          <c:y val="8.1325856995148327E-2"/>
          <c:w val="0.86562843038729642"/>
          <c:h val="0.684757019008988"/>
        </c:manualLayout>
      </c:layout>
      <c:barChart>
        <c:barDir val="col"/>
        <c:grouping val="stacked"/>
        <c:varyColors val="0"/>
        <c:ser>
          <c:idx val="0"/>
          <c:order val="0"/>
          <c:tx>
            <c:v>Flavanone rutinoside</c:v>
          </c:tx>
          <c:spPr>
            <a:solidFill>
              <a:sysClr val="windowText" lastClr="000000"/>
            </a:solidFill>
          </c:spPr>
          <c:invertIfNegative val="0"/>
          <c:cat>
            <c:strRef>
              <c:f>总表!$A$48:$A$86</c:f>
              <c:strCache>
                <c:ptCount val="39"/>
                <c:pt idx="0">
                  <c:v>HB</c:v>
                </c:pt>
                <c:pt idx="1">
                  <c:v>FC</c:v>
                </c:pt>
                <c:pt idx="2">
                  <c:v>HFL6</c:v>
                </c:pt>
                <c:pt idx="3">
                  <c:v>HFL7</c:v>
                </c:pt>
                <c:pt idx="4">
                  <c:v>HFw1</c:v>
                </c:pt>
                <c:pt idx="5">
                  <c:v>HFW2</c:v>
                </c:pt>
                <c:pt idx="6">
                  <c:v>HF7</c:v>
                </c:pt>
                <c:pt idx="7">
                  <c:v>HF30</c:v>
                </c:pt>
                <c:pt idx="8">
                  <c:v>HF39</c:v>
                </c:pt>
                <c:pt idx="9">
                  <c:v>HF59</c:v>
                </c:pt>
                <c:pt idx="10">
                  <c:v>HF63</c:v>
                </c:pt>
                <c:pt idx="11">
                  <c:v>HF75</c:v>
                </c:pt>
                <c:pt idx="12">
                  <c:v>HF78</c:v>
                </c:pt>
                <c:pt idx="13">
                  <c:v>HF80</c:v>
                </c:pt>
                <c:pt idx="14">
                  <c:v>HF82</c:v>
                </c:pt>
                <c:pt idx="15">
                  <c:v>HF88</c:v>
                </c:pt>
                <c:pt idx="16">
                  <c:v>HF108</c:v>
                </c:pt>
                <c:pt idx="17">
                  <c:v>HF111</c:v>
                </c:pt>
                <c:pt idx="18">
                  <c:v>HF112</c:v>
                </c:pt>
                <c:pt idx="19">
                  <c:v>HF149</c:v>
                </c:pt>
                <c:pt idx="20">
                  <c:v>HF150</c:v>
                </c:pt>
                <c:pt idx="21">
                  <c:v>HF154</c:v>
                </c:pt>
                <c:pt idx="22">
                  <c:v>HF156</c:v>
                </c:pt>
                <c:pt idx="23">
                  <c:v>HF159</c:v>
                </c:pt>
                <c:pt idx="24">
                  <c:v>HF165</c:v>
                </c:pt>
                <c:pt idx="25">
                  <c:v>HF168</c:v>
                </c:pt>
                <c:pt idx="26">
                  <c:v>HF170</c:v>
                </c:pt>
                <c:pt idx="27">
                  <c:v>HF172</c:v>
                </c:pt>
                <c:pt idx="28">
                  <c:v>HF187</c:v>
                </c:pt>
                <c:pt idx="29">
                  <c:v>HF188</c:v>
                </c:pt>
                <c:pt idx="30">
                  <c:v>HF197</c:v>
                </c:pt>
                <c:pt idx="31">
                  <c:v>HF198</c:v>
                </c:pt>
                <c:pt idx="32">
                  <c:v>HF203</c:v>
                </c:pt>
                <c:pt idx="33">
                  <c:v>HF204</c:v>
                </c:pt>
                <c:pt idx="34">
                  <c:v>HF205</c:v>
                </c:pt>
                <c:pt idx="35">
                  <c:v>HF208</c:v>
                </c:pt>
                <c:pt idx="36">
                  <c:v>HF210</c:v>
                </c:pt>
                <c:pt idx="37">
                  <c:v>HF213</c:v>
                </c:pt>
                <c:pt idx="38">
                  <c:v>HF214</c:v>
                </c:pt>
              </c:strCache>
            </c:strRef>
          </c:cat>
          <c:val>
            <c:numRef>
              <c:f>总表!$B$48:$B$86</c:f>
              <c:numCache>
                <c:formatCode>0.00;[Red]0.00</c:formatCode>
                <c:ptCount val="39"/>
                <c:pt idx="0" formatCode="General">
                  <c:v>0</c:v>
                </c:pt>
                <c:pt idx="1">
                  <c:v>27.183351866347</c:v>
                </c:pt>
                <c:pt idx="2" formatCode="0.00_ ">
                  <c:v>1.7789131960972675</c:v>
                </c:pt>
                <c:pt idx="3" formatCode="0.00_ ">
                  <c:v>2.7717516722327402</c:v>
                </c:pt>
                <c:pt idx="4" formatCode="0.00_ ">
                  <c:v>5.6031529356305247</c:v>
                </c:pt>
                <c:pt idx="5" formatCode="0.00_ ">
                  <c:v>2.6143687355922141</c:v>
                </c:pt>
                <c:pt idx="6" formatCode="0.00_ ">
                  <c:v>3.0171023589746646</c:v>
                </c:pt>
                <c:pt idx="7" formatCode="0.00_ ">
                  <c:v>2.4312228191624192</c:v>
                </c:pt>
                <c:pt idx="8" formatCode="0.00_ ">
                  <c:v>2.7629003229322158</c:v>
                </c:pt>
                <c:pt idx="9" formatCode="0.00_ ">
                  <c:v>5.2215553597322382</c:v>
                </c:pt>
                <c:pt idx="10" formatCode="0.00_ ">
                  <c:v>1.1345095827780487</c:v>
                </c:pt>
                <c:pt idx="11" formatCode="0.00_ ">
                  <c:v>1.4221224847896983</c:v>
                </c:pt>
                <c:pt idx="12" formatCode="0.00_ ">
                  <c:v>1.6554656714839389</c:v>
                </c:pt>
                <c:pt idx="13" formatCode="0.00_ ">
                  <c:v>1.3882442811648474</c:v>
                </c:pt>
                <c:pt idx="14" formatCode="0.00_ ">
                  <c:v>3.0217738890161776</c:v>
                </c:pt>
                <c:pt idx="15" formatCode="0.00_ ">
                  <c:v>1.372552563675014</c:v>
                </c:pt>
                <c:pt idx="16" formatCode="0.00_ ">
                  <c:v>1.4953774919902063</c:v>
                </c:pt>
                <c:pt idx="17" formatCode="0.00_ ">
                  <c:v>2.0527669772774018</c:v>
                </c:pt>
                <c:pt idx="18" formatCode="0.00_ ">
                  <c:v>5.5346196393853999</c:v>
                </c:pt>
                <c:pt idx="19" formatCode="0.00_ ">
                  <c:v>2.0114328154646532</c:v>
                </c:pt>
                <c:pt idx="20" formatCode="0.00_ ">
                  <c:v>2.4169935607978892</c:v>
                </c:pt>
                <c:pt idx="21" formatCode="0.00_ ">
                  <c:v>2.706958696920891</c:v>
                </c:pt>
                <c:pt idx="22" formatCode="0.00_ ">
                  <c:v>1.6966863541395067</c:v>
                </c:pt>
                <c:pt idx="23" formatCode="0.00_ ">
                  <c:v>5.7132311925091557</c:v>
                </c:pt>
                <c:pt idx="24" formatCode="0.00_ ">
                  <c:v>2.6634402010725644</c:v>
                </c:pt>
                <c:pt idx="25" formatCode="0.00_ ">
                  <c:v>5.3449866024788406</c:v>
                </c:pt>
                <c:pt idx="26" formatCode="0.00_ ">
                  <c:v>1.1633797167170472</c:v>
                </c:pt>
                <c:pt idx="27" formatCode="0.00_ ">
                  <c:v>3.2974902714264656</c:v>
                </c:pt>
                <c:pt idx="28" formatCode="0.00_ ">
                  <c:v>1.6688696804200382</c:v>
                </c:pt>
                <c:pt idx="29" formatCode="0.00_ ">
                  <c:v>1.0495374574593495</c:v>
                </c:pt>
                <c:pt idx="30" formatCode="0.00_ ">
                  <c:v>2.7257688603952501</c:v>
                </c:pt>
                <c:pt idx="31" formatCode="0.00_ ">
                  <c:v>1.8550273782905793</c:v>
                </c:pt>
                <c:pt idx="32" formatCode="0.00_ ">
                  <c:v>1.2933566209523149</c:v>
                </c:pt>
                <c:pt idx="33" formatCode="0.00_ ">
                  <c:v>1.6793452788133492</c:v>
                </c:pt>
                <c:pt idx="34" formatCode="0.00_ ">
                  <c:v>1.8925285595839132</c:v>
                </c:pt>
                <c:pt idx="35" formatCode="0.00_ ">
                  <c:v>4.4768408841384959</c:v>
                </c:pt>
                <c:pt idx="36" formatCode="0.00_ ">
                  <c:v>2.1688077210714272</c:v>
                </c:pt>
                <c:pt idx="37" formatCode="0.00_ ">
                  <c:v>1.4131905114712406</c:v>
                </c:pt>
                <c:pt idx="38" formatCode="0.00_ ">
                  <c:v>1.58622949169130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81-4C3D-B735-D58EE920A6A4}"/>
            </c:ext>
          </c:extLst>
        </c:ser>
        <c:ser>
          <c:idx val="1"/>
          <c:order val="1"/>
          <c:tx>
            <c:v>Flavanone neohesperidoside</c:v>
          </c:tx>
          <c:invertIfNegative val="0"/>
          <c:dPt>
            <c:idx val="30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2-A681-4C3D-B735-D58EE920A6A4}"/>
              </c:ext>
            </c:extLst>
          </c:dPt>
          <c:cat>
            <c:strRef>
              <c:f>总表!$A$48:$A$86</c:f>
              <c:strCache>
                <c:ptCount val="39"/>
                <c:pt idx="0">
                  <c:v>HB</c:v>
                </c:pt>
                <c:pt idx="1">
                  <c:v>FC</c:v>
                </c:pt>
                <c:pt idx="2">
                  <c:v>HFL6</c:v>
                </c:pt>
                <c:pt idx="3">
                  <c:v>HFL7</c:v>
                </c:pt>
                <c:pt idx="4">
                  <c:v>HFw1</c:v>
                </c:pt>
                <c:pt idx="5">
                  <c:v>HFW2</c:v>
                </c:pt>
                <c:pt idx="6">
                  <c:v>HF7</c:v>
                </c:pt>
                <c:pt idx="7">
                  <c:v>HF30</c:v>
                </c:pt>
                <c:pt idx="8">
                  <c:v>HF39</c:v>
                </c:pt>
                <c:pt idx="9">
                  <c:v>HF59</c:v>
                </c:pt>
                <c:pt idx="10">
                  <c:v>HF63</c:v>
                </c:pt>
                <c:pt idx="11">
                  <c:v>HF75</c:v>
                </c:pt>
                <c:pt idx="12">
                  <c:v>HF78</c:v>
                </c:pt>
                <c:pt idx="13">
                  <c:v>HF80</c:v>
                </c:pt>
                <c:pt idx="14">
                  <c:v>HF82</c:v>
                </c:pt>
                <c:pt idx="15">
                  <c:v>HF88</c:v>
                </c:pt>
                <c:pt idx="16">
                  <c:v>HF108</c:v>
                </c:pt>
                <c:pt idx="17">
                  <c:v>HF111</c:v>
                </c:pt>
                <c:pt idx="18">
                  <c:v>HF112</c:v>
                </c:pt>
                <c:pt idx="19">
                  <c:v>HF149</c:v>
                </c:pt>
                <c:pt idx="20">
                  <c:v>HF150</c:v>
                </c:pt>
                <c:pt idx="21">
                  <c:v>HF154</c:v>
                </c:pt>
                <c:pt idx="22">
                  <c:v>HF156</c:v>
                </c:pt>
                <c:pt idx="23">
                  <c:v>HF159</c:v>
                </c:pt>
                <c:pt idx="24">
                  <c:v>HF165</c:v>
                </c:pt>
                <c:pt idx="25">
                  <c:v>HF168</c:v>
                </c:pt>
                <c:pt idx="26">
                  <c:v>HF170</c:v>
                </c:pt>
                <c:pt idx="27">
                  <c:v>HF172</c:v>
                </c:pt>
                <c:pt idx="28">
                  <c:v>HF187</c:v>
                </c:pt>
                <c:pt idx="29">
                  <c:v>HF188</c:v>
                </c:pt>
                <c:pt idx="30">
                  <c:v>HF197</c:v>
                </c:pt>
                <c:pt idx="31">
                  <c:v>HF198</c:v>
                </c:pt>
                <c:pt idx="32">
                  <c:v>HF203</c:v>
                </c:pt>
                <c:pt idx="33">
                  <c:v>HF204</c:v>
                </c:pt>
                <c:pt idx="34">
                  <c:v>HF205</c:v>
                </c:pt>
                <c:pt idx="35">
                  <c:v>HF208</c:v>
                </c:pt>
                <c:pt idx="36">
                  <c:v>HF210</c:v>
                </c:pt>
                <c:pt idx="37">
                  <c:v>HF213</c:v>
                </c:pt>
                <c:pt idx="38">
                  <c:v>HF214</c:v>
                </c:pt>
              </c:strCache>
            </c:strRef>
          </c:cat>
          <c:val>
            <c:numRef>
              <c:f>总表!$C$48:$C$86</c:f>
              <c:numCache>
                <c:formatCode>General</c:formatCode>
                <c:ptCount val="39"/>
                <c:pt idx="0" formatCode="0.00;[Red]0.00">
                  <c:v>30.094265214678586</c:v>
                </c:pt>
                <c:pt idx="1">
                  <c:v>0</c:v>
                </c:pt>
                <c:pt idx="2" formatCode="0.00;[Red]0.00">
                  <c:v>30.383823400284342</c:v>
                </c:pt>
                <c:pt idx="3" formatCode="0.00;[Red]0.00">
                  <c:v>30.575946354046138</c:v>
                </c:pt>
                <c:pt idx="4" formatCode="0.00;[Red]0.00">
                  <c:v>33.060934050888164</c:v>
                </c:pt>
                <c:pt idx="5" formatCode="0.00;[Red]0.00">
                  <c:v>9.2305363933693609</c:v>
                </c:pt>
                <c:pt idx="6" formatCode="0.00;[Red]0.00">
                  <c:v>29.123523863679882</c:v>
                </c:pt>
                <c:pt idx="7" formatCode="0.00;[Red]0.00">
                  <c:v>11.006251960839554</c:v>
                </c:pt>
                <c:pt idx="8" formatCode="0.00;[Red]0.00">
                  <c:v>8.9841850282186044</c:v>
                </c:pt>
                <c:pt idx="9" formatCode="0.00;[Red]0.00">
                  <c:v>45.862784100030069</c:v>
                </c:pt>
                <c:pt idx="10" formatCode="0.00;[Red]0.00">
                  <c:v>6.8086674516076329</c:v>
                </c:pt>
                <c:pt idx="11" formatCode="0.00;[Red]0.00">
                  <c:v>5.6242624407615986</c:v>
                </c:pt>
                <c:pt idx="12" formatCode="0.00;[Red]0.00">
                  <c:v>13.194427783522519</c:v>
                </c:pt>
                <c:pt idx="13" formatCode="0.00;[Red]0.00">
                  <c:v>8.4408636953504956</c:v>
                </c:pt>
                <c:pt idx="14" formatCode="0.00;[Red]0.00">
                  <c:v>17.4213705755175</c:v>
                </c:pt>
                <c:pt idx="15" formatCode="0.00;[Red]0.00">
                  <c:v>3.6910096649156188</c:v>
                </c:pt>
                <c:pt idx="16" formatCode="0.00;[Red]0.00">
                  <c:v>3.4555167374662905</c:v>
                </c:pt>
                <c:pt idx="17" formatCode="0.00;[Red]0.00">
                  <c:v>4.8055732950550736</c:v>
                </c:pt>
                <c:pt idx="18" formatCode="0.00;[Red]0.00">
                  <c:v>24.391902106225341</c:v>
                </c:pt>
                <c:pt idx="19" formatCode="0.00;[Red]0.00">
                  <c:v>8.3005582558807784</c:v>
                </c:pt>
                <c:pt idx="20" formatCode="0.00;[Red]0.00">
                  <c:v>13.037105682788939</c:v>
                </c:pt>
                <c:pt idx="21" formatCode="0.00;[Red]0.00">
                  <c:v>18.512170191238251</c:v>
                </c:pt>
                <c:pt idx="22" formatCode="0.00;[Red]0.00">
                  <c:v>10.065793181072854</c:v>
                </c:pt>
                <c:pt idx="23" formatCode="0.00;[Red]0.00">
                  <c:v>38.043856081875305</c:v>
                </c:pt>
                <c:pt idx="24" formatCode="0.00;[Red]0.00">
                  <c:v>10.179453606288346</c:v>
                </c:pt>
                <c:pt idx="25" formatCode="0.00;[Red]0.00">
                  <c:v>35.349288975295345</c:v>
                </c:pt>
                <c:pt idx="26" formatCode="0.00;[Red]0.00">
                  <c:v>2.8803546319724389</c:v>
                </c:pt>
                <c:pt idx="27" formatCode="0.00;[Red]0.00">
                  <c:v>24.396625454893268</c:v>
                </c:pt>
                <c:pt idx="28" formatCode="0.00;[Red]0.00">
                  <c:v>4.9181740791578408</c:v>
                </c:pt>
                <c:pt idx="29" formatCode="0.00;[Red]0.00">
                  <c:v>2.8597673418429452</c:v>
                </c:pt>
                <c:pt idx="30" formatCode="0.00;[Red]0.00">
                  <c:v>21.86501664603075</c:v>
                </c:pt>
                <c:pt idx="31" formatCode="0.00;[Red]0.00">
                  <c:v>5.4261809738575479</c:v>
                </c:pt>
                <c:pt idx="32" formatCode="0.00;[Red]0.00">
                  <c:v>7.0652421881735075</c:v>
                </c:pt>
                <c:pt idx="33" formatCode="0.00;[Red]0.00">
                  <c:v>7.5555277544153112</c:v>
                </c:pt>
                <c:pt idx="34" formatCode="0.00;[Red]0.00">
                  <c:v>6.6109937129317196</c:v>
                </c:pt>
                <c:pt idx="35" formatCode="0.00;[Red]0.00">
                  <c:v>10.356299175789241</c:v>
                </c:pt>
                <c:pt idx="36" formatCode="0.00;[Red]0.00">
                  <c:v>12.912516600265604</c:v>
                </c:pt>
                <c:pt idx="37" formatCode="0.00;[Red]0.00">
                  <c:v>3.9362395392007929</c:v>
                </c:pt>
                <c:pt idx="38" formatCode="0.00;[Red]0.00">
                  <c:v>4.06806344991252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681-4C3D-B735-D58EE920A6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161745536"/>
        <c:axId val="68112768"/>
      </c:barChart>
      <c:catAx>
        <c:axId val="16174553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8112768"/>
        <c:crosses val="autoZero"/>
        <c:auto val="1"/>
        <c:lblAlgn val="ctr"/>
        <c:lblOffset val="100"/>
        <c:noMultiLvlLbl val="0"/>
      </c:catAx>
      <c:valAx>
        <c:axId val="68112768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5875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16174553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55174797687637855"/>
          <c:y val="7.6023391812865493E-2"/>
          <c:w val="0.42643526009779537"/>
          <c:h val="9.9205691393838932E-2"/>
        </c:manualLayout>
      </c:layout>
      <c:overlay val="0"/>
      <c:txPr>
        <a:bodyPr/>
        <a:lstStyle/>
        <a:p>
          <a:pPr>
            <a:defRPr sz="1400"/>
          </a:pPr>
          <a:endParaRPr lang="zh-CN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49254</cdr:y>
    </cdr:from>
    <cdr:to>
      <cdr:x>0.02825</cdr:x>
      <cdr:y>0.82843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332123" y="1589423"/>
          <a:ext cx="857442" cy="1931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endParaRPr lang="zh-CN" altLang="en-US" sz="120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281</cdr:x>
      <cdr:y>0.35606</cdr:y>
    </cdr:from>
    <cdr:to>
      <cdr:x>0.03125</cdr:x>
      <cdr:y>0.69705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-313073" y="1227473"/>
          <a:ext cx="857442" cy="1931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endParaRPr lang="zh-CN" altLang="en-US" sz="1100">
            <a:latin typeface="Times New Roman" pitchFamily="18" charset="0"/>
            <a:ea typeface="+mn-ea"/>
            <a:cs typeface="Times New Roman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EFC624-CCC5-4DF7-9969-8CE34D461099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48C011-3467-481B-BB65-5156304CA9F8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9396D3-2BCA-43FC-B30E-880719E8EDAE}" type="datetimeFigureOut">
              <a:rPr lang="zh-CN" altLang="en-US" smtClean="0"/>
              <a:t>2021/3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A707E-EAA4-4C1E-88C2-86434D40414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/>
          <p:cNvGraphicFramePr/>
          <p:nvPr>
            <p:extLst>
              <p:ext uri="{D42A27DB-BD31-4B8C-83A1-F6EECF244321}">
                <p14:modId xmlns:p14="http://schemas.microsoft.com/office/powerpoint/2010/main" val="868262278"/>
              </p:ext>
            </p:extLst>
          </p:nvPr>
        </p:nvGraphicFramePr>
        <p:xfrm>
          <a:off x="1971316" y="3371052"/>
          <a:ext cx="8446239" cy="17575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图表 5"/>
          <p:cNvGraphicFramePr/>
          <p:nvPr>
            <p:extLst>
              <p:ext uri="{D42A27DB-BD31-4B8C-83A1-F6EECF244321}">
                <p14:modId xmlns:p14="http://schemas.microsoft.com/office/powerpoint/2010/main" val="3093912265"/>
              </p:ext>
            </p:extLst>
          </p:nvPr>
        </p:nvGraphicFramePr>
        <p:xfrm>
          <a:off x="1831955" y="4922644"/>
          <a:ext cx="8718669" cy="19778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文本框 6"/>
          <p:cNvSpPr txBox="1"/>
          <p:nvPr/>
        </p:nvSpPr>
        <p:spPr>
          <a:xfrm rot="10800000">
            <a:off x="1605168" y="4860257"/>
            <a:ext cx="338554" cy="13450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Relative content (%)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439639" y="3026433"/>
            <a:ext cx="348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黑体" panose="02010609060101010101" pitchFamily="49" charset="-122"/>
                <a:ea typeface="黑体" panose="02010609060101010101" pitchFamily="49" charset="-122"/>
              </a:rPr>
              <a:t>b</a:t>
            </a:r>
            <a:endParaRPr lang="zh-CN" altLang="en-US" sz="2400" b="1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 rot="10800000">
            <a:off x="1613719" y="3527197"/>
            <a:ext cx="338554" cy="121971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charset="0"/>
                <a:cs typeface="Times New Roman" panose="02020603050405020304" charset="0"/>
              </a:defRPr>
            </a:lvl1pPr>
          </a:lstStyle>
          <a:p>
            <a:r>
              <a:rPr lang="en-US" altLang="zh-CN" sz="1000" dirty="0"/>
              <a:t>Content (mg/</a:t>
            </a:r>
            <a:r>
              <a:rPr lang="en-US" altLang="zh-CN" sz="1000" dirty="0" err="1"/>
              <a:t>g.DW</a:t>
            </a:r>
            <a:r>
              <a:rPr lang="en-US" altLang="zh-CN" sz="1000" dirty="0"/>
              <a:t>)</a:t>
            </a:r>
          </a:p>
        </p:txBody>
      </p:sp>
      <p:sp>
        <p:nvSpPr>
          <p:cNvPr id="10" name="文本框 9"/>
          <p:cNvSpPr txBox="1"/>
          <p:nvPr/>
        </p:nvSpPr>
        <p:spPr>
          <a:xfrm>
            <a:off x="1411999" y="-173148"/>
            <a:ext cx="348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黑体" panose="02010609060101010101" pitchFamily="49" charset="-122"/>
                <a:ea typeface="黑体" panose="02010609060101010101" pitchFamily="49" charset="-122"/>
              </a:rPr>
              <a:t>a</a:t>
            </a:r>
            <a:endParaRPr lang="zh-CN" altLang="en-US" sz="2400" b="1" dirty="0">
              <a:latin typeface="黑体" panose="02010609060101010101" pitchFamily="49" charset="-122"/>
              <a:ea typeface="黑体" panose="02010609060101010101" pitchFamily="49" charset="-122"/>
            </a:endParaRPr>
          </a:p>
        </p:txBody>
      </p:sp>
      <p:graphicFrame>
        <p:nvGraphicFramePr>
          <p:cNvPr id="12" name="图表 11">
            <a:extLst>
              <a:ext uri="{FF2B5EF4-FFF2-40B4-BE49-F238E27FC236}">
                <a16:creationId xmlns:a16="http://schemas.microsoft.com/office/drawing/2014/main" id="{00000000-0008-0000-07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4485676"/>
              </p:ext>
            </p:extLst>
          </p:nvPr>
        </p:nvGraphicFramePr>
        <p:xfrm>
          <a:off x="1481433" y="1572366"/>
          <a:ext cx="8957965" cy="19038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图表 12">
            <a:extLst>
              <a:ext uri="{FF2B5EF4-FFF2-40B4-BE49-F238E27FC236}">
                <a16:creationId xmlns:a16="http://schemas.microsoft.com/office/drawing/2014/main" id="{00000000-0008-0000-07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5407083"/>
              </p:ext>
            </p:extLst>
          </p:nvPr>
        </p:nvGraphicFramePr>
        <p:xfrm>
          <a:off x="1236685" y="11200"/>
          <a:ext cx="9313939" cy="217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B94F4197-B2CA-4DF4-9B22-145AE860249B}"/>
              </a:ext>
            </a:extLst>
          </p:cNvPr>
          <p:cNvSpPr txBox="1"/>
          <p:nvPr/>
        </p:nvSpPr>
        <p:spPr>
          <a:xfrm rot="10800000">
            <a:off x="1606255" y="1586582"/>
            <a:ext cx="338554" cy="134508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Relative content (%)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56C1594-3347-4F07-B371-EBCEAE79F3A0}"/>
              </a:ext>
            </a:extLst>
          </p:cNvPr>
          <p:cNvSpPr txBox="1"/>
          <p:nvPr/>
        </p:nvSpPr>
        <p:spPr>
          <a:xfrm rot="10800000">
            <a:off x="1641376" y="213742"/>
            <a:ext cx="338554" cy="121971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>
            <a:defPPr>
              <a:defRPr lang="zh-CN"/>
            </a:defPPr>
            <a:lvl1pPr>
              <a:defRPr sz="1400" b="1">
                <a:latin typeface="Times New Roman" panose="02020603050405020304" charset="0"/>
                <a:cs typeface="Times New Roman" panose="02020603050405020304" charset="0"/>
              </a:defRPr>
            </a:lvl1pPr>
          </a:lstStyle>
          <a:p>
            <a:r>
              <a:rPr lang="en-US" altLang="zh-CN" sz="1000" dirty="0"/>
              <a:t>Content (mg/</a:t>
            </a:r>
            <a:r>
              <a:rPr lang="en-US" altLang="zh-CN" sz="1000" dirty="0" err="1"/>
              <a:t>g.DW</a:t>
            </a:r>
            <a:r>
              <a:rPr lang="en-US" altLang="zh-CN" sz="1000" dirty="0"/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4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黑体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古</dc:creator>
  <cp:lastModifiedBy>李 古</cp:lastModifiedBy>
  <cp:revision>12</cp:revision>
  <dcterms:created xsi:type="dcterms:W3CDTF">2021-02-28T07:26:00Z</dcterms:created>
  <dcterms:modified xsi:type="dcterms:W3CDTF">2021-03-03T13:48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2</vt:lpwstr>
  </property>
</Properties>
</file>